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Default Extension="ti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8" r:id="rId2"/>
    <p:sldId id="260" r:id="rId3"/>
    <p:sldId id="266" r:id="rId4"/>
    <p:sldId id="265" r:id="rId5"/>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7" autoAdjust="0"/>
    <p:restoredTop sz="94660"/>
  </p:normalViewPr>
  <p:slideViewPr>
    <p:cSldViewPr snapToGrid="0">
      <p:cViewPr varScale="1">
        <p:scale>
          <a:sx n="114" d="100"/>
          <a:sy n="114" d="100"/>
        </p:scale>
        <p:origin x="474"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286BB77-7F24-4115-0694-532A5B5B6556}"/>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02B3E7D4-4C79-0C4D-17FD-C985E4D090B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8911C900-1265-A1AF-FE57-7A21CB98634A}"/>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5" name="바닥글 개체 틀 4">
            <a:extLst>
              <a:ext uri="{FF2B5EF4-FFF2-40B4-BE49-F238E27FC236}">
                <a16:creationId xmlns:a16="http://schemas.microsoft.com/office/drawing/2014/main" id="{B5B4D2DB-4F66-AE9F-EDDE-053FC635799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D10DBFD-6442-1CCA-4B1D-99DC2FCAA09C}"/>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103237174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2868D1F-9A2E-08AD-E1F7-EDA41CE8E016}"/>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456ADFF7-F4B8-3BCD-26FC-FE481E6181EF}"/>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DF70D2D4-609A-CFCF-0547-0EDD283FE58F}"/>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5" name="바닥글 개체 틀 4">
            <a:extLst>
              <a:ext uri="{FF2B5EF4-FFF2-40B4-BE49-F238E27FC236}">
                <a16:creationId xmlns:a16="http://schemas.microsoft.com/office/drawing/2014/main" id="{20A55060-29BB-456C-FEE5-315494305FA7}"/>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ACBFC13-E5EB-66BF-6C10-471F1052DC1B}"/>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3251295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F4FB5AB4-76A0-54AC-DFE3-D634141577C8}"/>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E5033735-4CD0-C107-21A8-4DB1E18912CE}"/>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97FFBB7F-0CEC-2262-91F9-A9770B5B4E22}"/>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5" name="바닥글 개체 틀 4">
            <a:extLst>
              <a:ext uri="{FF2B5EF4-FFF2-40B4-BE49-F238E27FC236}">
                <a16:creationId xmlns:a16="http://schemas.microsoft.com/office/drawing/2014/main" id="{89D40CEA-05FA-5F7F-B00C-3467584FDB8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43C14985-5F09-D213-083F-53227DF0E69F}"/>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5616794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688C8A8-CDB4-D48A-3BED-64576741D6C3}"/>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4A350C88-1870-B099-F84A-163C193D0197}"/>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FB614188-F590-F841-469B-D6114B996D8D}"/>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5" name="바닥글 개체 틀 4">
            <a:extLst>
              <a:ext uri="{FF2B5EF4-FFF2-40B4-BE49-F238E27FC236}">
                <a16:creationId xmlns:a16="http://schemas.microsoft.com/office/drawing/2014/main" id="{1C5412EA-B184-BA4B-5BD8-39C857239D22}"/>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C9575C96-D10D-8C42-976F-B8E8BD022DF9}"/>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23039523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3C2E89F-7EA2-0BC6-F695-7BE89F0D2FB9}"/>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9594098F-7E33-B9BB-FB37-F48B00D492F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3E24E1BA-2B9A-6FC2-6FD0-4312E878DAA7}"/>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5" name="바닥글 개체 틀 4">
            <a:extLst>
              <a:ext uri="{FF2B5EF4-FFF2-40B4-BE49-F238E27FC236}">
                <a16:creationId xmlns:a16="http://schemas.microsoft.com/office/drawing/2014/main" id="{111D016D-C228-9757-A0B4-D8B42B24BA68}"/>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29D6011-6FC7-1E8F-62D8-784789F707E0}"/>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32668607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B4D61D4-D80A-5F27-2A3C-710136F21331}"/>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684844E2-4415-241C-681F-5257F177BB13}"/>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DC21372B-721F-E278-21E7-76C8FBB5BB4B}"/>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70013FB3-1CEE-A865-A529-D0322579FF64}"/>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6" name="바닥글 개체 틀 5">
            <a:extLst>
              <a:ext uri="{FF2B5EF4-FFF2-40B4-BE49-F238E27FC236}">
                <a16:creationId xmlns:a16="http://schemas.microsoft.com/office/drawing/2014/main" id="{61E7668E-A42D-C86B-E786-CB4C7DB6FCF1}"/>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74E73F56-E89F-0576-582A-9E7211B35ACC}"/>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39781805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F74C71D-1983-293B-9B25-A035C7D50F3B}"/>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869538A0-64E3-ED5E-079B-9033F4F96F3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6D8DD3BE-6620-49A2-FB83-F4B95E207F7A}"/>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92272A07-E213-80BF-FB1A-FAE6957A8C7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0EF32F89-807E-1873-B4B3-72F1C35D021A}"/>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2ED7BED4-C69A-B4FE-877E-12409B7E15D7}"/>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8" name="바닥글 개체 틀 7">
            <a:extLst>
              <a:ext uri="{FF2B5EF4-FFF2-40B4-BE49-F238E27FC236}">
                <a16:creationId xmlns:a16="http://schemas.microsoft.com/office/drawing/2014/main" id="{52DE80A6-9DA7-FF52-F06D-0CF860C787CE}"/>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BD09203E-F99E-BF35-F374-4DA9BD8486D0}"/>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53027032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7B6FAAB-533A-FAD5-23CD-84660A784A5B}"/>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5CC67BDE-3BD2-208C-C4F1-87CAA3F02651}"/>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4" name="바닥글 개체 틀 3">
            <a:extLst>
              <a:ext uri="{FF2B5EF4-FFF2-40B4-BE49-F238E27FC236}">
                <a16:creationId xmlns:a16="http://schemas.microsoft.com/office/drawing/2014/main" id="{C153EEE4-3D1D-2455-1883-078CF535EBC2}"/>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FA6C4836-C375-84A1-F13C-6E3484B2015F}"/>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29849181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8F684733-FE1C-BD7F-DB89-C20A4198482C}"/>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3" name="바닥글 개체 틀 2">
            <a:extLst>
              <a:ext uri="{FF2B5EF4-FFF2-40B4-BE49-F238E27FC236}">
                <a16:creationId xmlns:a16="http://schemas.microsoft.com/office/drawing/2014/main" id="{B41DA7B7-F076-74CC-A06B-5A0797ED3238}"/>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DB8F461A-1A78-F388-453B-76DD4E92F7BD}"/>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14302772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5F3F88C-C8D3-2E17-BDC9-52EFF164F26A}"/>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1705784F-7DB4-57DD-B39C-3AB74414E5E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0BBB6846-D57B-7E2D-2B60-0CB6E158F35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BDEDAC9F-D8A5-7D73-2442-DB3D7D4F18E6}"/>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6" name="바닥글 개체 틀 5">
            <a:extLst>
              <a:ext uri="{FF2B5EF4-FFF2-40B4-BE49-F238E27FC236}">
                <a16:creationId xmlns:a16="http://schemas.microsoft.com/office/drawing/2014/main" id="{1393DDA7-0580-92BA-3DE1-0E88C6EB794E}"/>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DF09FD9F-7B1F-B416-A36C-C456C6421F3A}"/>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200129650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FCE1319-2E63-7781-986B-8FE8146341C5}"/>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225B806B-1D26-883E-BB58-F211AF5F86A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74A470D4-67B0-6A8D-BED6-8D17EEF609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80F2CA8F-47A9-0384-64CB-69E81B6410BF}"/>
              </a:ext>
            </a:extLst>
          </p:cNvPr>
          <p:cNvSpPr>
            <a:spLocks noGrp="1"/>
          </p:cNvSpPr>
          <p:nvPr>
            <p:ph type="dt" sz="half" idx="10"/>
          </p:nvPr>
        </p:nvSpPr>
        <p:spPr/>
        <p:txBody>
          <a:bodyPr/>
          <a:lstStyle/>
          <a:p>
            <a:fld id="{B653822C-B285-4685-AFA3-9E02B7DF03FE}" type="datetimeFigureOut">
              <a:rPr lang="ko-KR" altLang="en-US" smtClean="0"/>
              <a:t>2022-07-25</a:t>
            </a:fld>
            <a:endParaRPr lang="ko-KR" altLang="en-US"/>
          </a:p>
        </p:txBody>
      </p:sp>
      <p:sp>
        <p:nvSpPr>
          <p:cNvPr id="6" name="바닥글 개체 틀 5">
            <a:extLst>
              <a:ext uri="{FF2B5EF4-FFF2-40B4-BE49-F238E27FC236}">
                <a16:creationId xmlns:a16="http://schemas.microsoft.com/office/drawing/2014/main" id="{D8E36D0E-9894-4860-AD2D-5DFC06DC459E}"/>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88F143D3-06AE-0630-F543-25C3035FCE3A}"/>
              </a:ext>
            </a:extLst>
          </p:cNvPr>
          <p:cNvSpPr>
            <a:spLocks noGrp="1"/>
          </p:cNvSpPr>
          <p:nvPr>
            <p:ph type="sldNum" sz="quarter" idx="12"/>
          </p:nvPr>
        </p:nvSpPr>
        <p:spPr/>
        <p:txBody>
          <a:body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28498298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58CF30D1-3851-9265-5EBF-C48EDDE5C4A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C9C5951A-8A07-8D04-D034-197D9D3A739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932532F8-D3D4-C641-8597-4F6276D536D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653822C-B285-4685-AFA3-9E02B7DF03FE}" type="datetimeFigureOut">
              <a:rPr lang="ko-KR" altLang="en-US" smtClean="0"/>
              <a:t>2022-07-25</a:t>
            </a:fld>
            <a:endParaRPr lang="ko-KR" altLang="en-US"/>
          </a:p>
        </p:txBody>
      </p:sp>
      <p:sp>
        <p:nvSpPr>
          <p:cNvPr id="5" name="바닥글 개체 틀 4">
            <a:extLst>
              <a:ext uri="{FF2B5EF4-FFF2-40B4-BE49-F238E27FC236}">
                <a16:creationId xmlns:a16="http://schemas.microsoft.com/office/drawing/2014/main" id="{2C0ED437-E507-0348-1620-0362561441B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DFF07A57-5765-4952-68CA-F1F7376A96F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B3160D3-00CA-4CB0-81F9-2F4014944F42}" type="slidenum">
              <a:rPr lang="ko-KR" altLang="en-US" smtClean="0"/>
              <a:t>‹#›</a:t>
            </a:fld>
            <a:endParaRPr lang="ko-KR" altLang="en-US"/>
          </a:p>
        </p:txBody>
      </p:sp>
    </p:spTree>
    <p:extLst>
      <p:ext uri="{BB962C8B-B14F-4D97-AF65-F5344CB8AC3E}">
        <p14:creationId xmlns:p14="http://schemas.microsoft.com/office/powerpoint/2010/main" val="19452533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ti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t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60870" y="1332468"/>
            <a:ext cx="10921901" cy="369460"/>
          </a:xfrm>
          <a:prstGeom prst="rect">
            <a:avLst/>
          </a:prstGeom>
          <a:noFill/>
        </p:spPr>
        <p:txBody>
          <a:bodyPr wrap="none" rtlCol="0">
            <a:spAutoFit/>
          </a:bodyPr>
          <a:lstStyle/>
          <a:p>
            <a:r>
              <a:rPr lang="en-US" altLang="ko-KR" sz="1801" dirty="0" smtClean="0"/>
              <a:t>Fig</a:t>
            </a:r>
            <a:r>
              <a:rPr lang="en-US" altLang="ko-KR" sz="1801" dirty="0" smtClean="0"/>
              <a:t>ure</a:t>
            </a:r>
            <a:r>
              <a:rPr lang="en-US" altLang="ko-KR" sz="1801" dirty="0" smtClean="0"/>
              <a:t> S1</a:t>
            </a:r>
            <a:r>
              <a:rPr lang="en-US" altLang="ko-KR" sz="1801" dirty="0"/>
              <a:t>. Increased amount of (A) acetate, (B) propionate and (C) butyrate when compared to blanks</a:t>
            </a:r>
            <a:endParaRPr lang="ko-KR" altLang="en-US" sz="1801" dirty="0"/>
          </a:p>
        </p:txBody>
      </p:sp>
      <p:pic>
        <p:nvPicPr>
          <p:cNvPr id="4" name="그림 3">
            <a:extLst>
              <a:ext uri="{FF2B5EF4-FFF2-40B4-BE49-F238E27FC236}">
                <a16:creationId xmlns:a16="http://schemas.microsoft.com/office/drawing/2014/main" id="{25F7CA58-5214-5239-BF13-C106F0E09FC4}"/>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75844" y="2204212"/>
            <a:ext cx="11640312" cy="3465576"/>
          </a:xfrm>
          <a:prstGeom prst="rect">
            <a:avLst/>
          </a:prstGeom>
        </p:spPr>
      </p:pic>
    </p:spTree>
    <p:extLst>
      <p:ext uri="{BB962C8B-B14F-4D97-AF65-F5344CB8AC3E}">
        <p14:creationId xmlns:p14="http://schemas.microsoft.com/office/powerpoint/2010/main" val="397427431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3609" y="1046200"/>
            <a:ext cx="11994091" cy="1200842"/>
          </a:xfrm>
          <a:prstGeom prst="rect">
            <a:avLst/>
          </a:prstGeom>
          <a:noFill/>
        </p:spPr>
        <p:txBody>
          <a:bodyPr wrap="square" rtlCol="0">
            <a:spAutoFit/>
          </a:bodyPr>
          <a:lstStyle/>
          <a:p>
            <a:r>
              <a:rPr lang="en-US" altLang="ko-KR" sz="1801" dirty="0" smtClean="0"/>
              <a:t>Figure S2</a:t>
            </a:r>
            <a:r>
              <a:rPr lang="en-US" altLang="ko-KR" sz="1801" dirty="0"/>
              <a:t>. Initial bacterial community structure of the subjects. (A) Two dimensional plot of the principle coordinate analysis (</a:t>
            </a:r>
            <a:r>
              <a:rPr lang="en-US" altLang="ko-KR" sz="1801" dirty="0" err="1"/>
              <a:t>PCoA</a:t>
            </a:r>
            <a:r>
              <a:rPr lang="en-US" altLang="ko-KR" sz="1801" dirty="0"/>
              <a:t>) based on Bray-Curtis dissimilarity of bacterial communities between the samples. (B) A </a:t>
            </a:r>
            <a:r>
              <a:rPr lang="en-US" altLang="ko-KR" sz="1801" dirty="0" err="1"/>
              <a:t>heatmap</a:t>
            </a:r>
            <a:r>
              <a:rPr lang="en-US" altLang="ko-KR" sz="1801" dirty="0"/>
              <a:t> based on the relative abundance of each phylum. (C) A </a:t>
            </a:r>
            <a:r>
              <a:rPr lang="en-US" altLang="ko-KR" sz="1801" dirty="0" err="1"/>
              <a:t>heatmap</a:t>
            </a:r>
            <a:r>
              <a:rPr lang="en-US" altLang="ko-KR" sz="1801" dirty="0"/>
              <a:t> based on the relative abundance of the 15 most abundant genera</a:t>
            </a:r>
            <a:endParaRPr lang="ko-KR" altLang="en-US" sz="1801" dirty="0"/>
          </a:p>
        </p:txBody>
      </p:sp>
      <p:pic>
        <p:nvPicPr>
          <p:cNvPr id="3" name="그림 2">
            <a:extLst>
              <a:ext uri="{FF2B5EF4-FFF2-40B4-BE49-F238E27FC236}">
                <a16:creationId xmlns:a16="http://schemas.microsoft.com/office/drawing/2014/main" id="{34C59758-B53A-76D9-080F-0AEB3B5B545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49276" y="2380903"/>
            <a:ext cx="11662756" cy="2872047"/>
          </a:xfrm>
          <a:prstGeom prst="rect">
            <a:avLst/>
          </a:prstGeom>
        </p:spPr>
      </p:pic>
    </p:spTree>
    <p:extLst>
      <p:ext uri="{BB962C8B-B14F-4D97-AF65-F5344CB8AC3E}">
        <p14:creationId xmlns:p14="http://schemas.microsoft.com/office/powerpoint/2010/main" val="12762502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75143" y="141845"/>
            <a:ext cx="11945408" cy="646587"/>
          </a:xfrm>
          <a:prstGeom prst="rect">
            <a:avLst/>
          </a:prstGeom>
          <a:noFill/>
        </p:spPr>
        <p:txBody>
          <a:bodyPr wrap="square" rtlCol="0">
            <a:spAutoFit/>
          </a:bodyPr>
          <a:lstStyle/>
          <a:p>
            <a:r>
              <a:rPr lang="en-US" altLang="ko-KR" sz="1801" dirty="0" smtClean="0"/>
              <a:t>Figure S3. </a:t>
            </a:r>
            <a:r>
              <a:rPr lang="en-US" altLang="ko-KR" sz="1801" dirty="0" err="1"/>
              <a:t>PCoA</a:t>
            </a:r>
            <a:r>
              <a:rPr lang="en-US" altLang="ko-KR" sz="1801" dirty="0"/>
              <a:t> plot showing the Bray-Curtis distance between the samples calculated based on the OTU composition in each subject. PERMANOVA results are shown above each plot</a:t>
            </a:r>
            <a:endParaRPr lang="ko-KR" altLang="en-US" sz="1801" dirty="0"/>
          </a:p>
        </p:txBody>
      </p:sp>
      <p:pic>
        <p:nvPicPr>
          <p:cNvPr id="4" name="그림 3" descr="지도이(가) 표시된 사진&#10;&#10;자동 생성된 설명">
            <a:extLst>
              <a:ext uri="{FF2B5EF4-FFF2-40B4-BE49-F238E27FC236}">
                <a16:creationId xmlns:a16="http://schemas.microsoft.com/office/drawing/2014/main" id="{3C186F23-5D31-76ED-C8FB-B81782A83696}"/>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1181859" y="954686"/>
            <a:ext cx="10058400" cy="5658612"/>
          </a:xfrm>
          <a:prstGeom prst="rect">
            <a:avLst/>
          </a:prstGeom>
        </p:spPr>
      </p:pic>
    </p:spTree>
    <p:extLst>
      <p:ext uri="{BB962C8B-B14F-4D97-AF65-F5344CB8AC3E}">
        <p14:creationId xmlns:p14="http://schemas.microsoft.com/office/powerpoint/2010/main" val="16707589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3609" y="84175"/>
            <a:ext cx="11994091" cy="923714"/>
          </a:xfrm>
          <a:prstGeom prst="rect">
            <a:avLst/>
          </a:prstGeom>
          <a:noFill/>
        </p:spPr>
        <p:txBody>
          <a:bodyPr wrap="square" rtlCol="0">
            <a:spAutoFit/>
          </a:bodyPr>
          <a:lstStyle/>
          <a:p>
            <a:r>
              <a:rPr lang="en-US" altLang="ko-KR" sz="1801" smtClean="0"/>
              <a:t>Figures S4. </a:t>
            </a:r>
            <a:r>
              <a:rPr lang="en-US" altLang="ko-KR" sz="1801" dirty="0"/>
              <a:t>Correlation coefficient between the true amount of short chain fatty acids and the amount of short chain fatty acids predicted by machine learning models based on (A) genus composition and (B) metabolic pathways.</a:t>
            </a:r>
            <a:endParaRPr lang="ko-KR" altLang="en-US" sz="1801" dirty="0"/>
          </a:p>
        </p:txBody>
      </p:sp>
      <p:pic>
        <p:nvPicPr>
          <p:cNvPr id="3" name="그림 2">
            <a:extLst>
              <a:ext uri="{FF2B5EF4-FFF2-40B4-BE49-F238E27FC236}">
                <a16:creationId xmlns:a16="http://schemas.microsoft.com/office/drawing/2014/main" id="{34708A16-CC4C-E7B0-32E8-401E84B09AF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139902" y="1007889"/>
            <a:ext cx="5656225" cy="5656225"/>
          </a:xfrm>
          <a:prstGeom prst="rect">
            <a:avLst/>
          </a:prstGeom>
        </p:spPr>
      </p:pic>
    </p:spTree>
    <p:extLst>
      <p:ext uri="{BB962C8B-B14F-4D97-AF65-F5344CB8AC3E}">
        <p14:creationId xmlns:p14="http://schemas.microsoft.com/office/powerpoint/2010/main" val="342076039"/>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95</TotalTime>
  <Words>160</Words>
  <Application>Microsoft Office PowerPoint</Application>
  <PresentationFormat>와이드스크린</PresentationFormat>
  <Paragraphs>4</Paragraphs>
  <Slides>4</Slides>
  <Notes>0</Notes>
  <HiddenSlides>0</HiddenSlides>
  <MMClips>0</MMClips>
  <ScaleCrop>false</ScaleCrop>
  <HeadingPairs>
    <vt:vector size="6" baseType="variant">
      <vt:variant>
        <vt:lpstr>사용한 글꼴</vt:lpstr>
      </vt:variant>
      <vt:variant>
        <vt:i4>2</vt:i4>
      </vt:variant>
      <vt:variant>
        <vt:lpstr>테마</vt:lpstr>
      </vt:variant>
      <vt:variant>
        <vt:i4>1</vt:i4>
      </vt:variant>
      <vt:variant>
        <vt:lpstr>슬라이드 제목</vt:lpstr>
      </vt:variant>
      <vt:variant>
        <vt:i4>4</vt:i4>
      </vt:variant>
    </vt:vector>
  </HeadingPairs>
  <TitlesOfParts>
    <vt:vector size="7" baseType="lpstr">
      <vt:lpstr>맑은 고딕</vt:lpstr>
      <vt:lpstr>Arial</vt:lpstr>
      <vt:lpstr>Office 테마</vt:lpstr>
      <vt:lpstr>PowerPoint 프레젠테이션</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nno Tatsuya</dc:creator>
  <cp:lastModifiedBy>user</cp:lastModifiedBy>
  <cp:revision>11</cp:revision>
  <dcterms:created xsi:type="dcterms:W3CDTF">2022-07-15T05:36:50Z</dcterms:created>
  <dcterms:modified xsi:type="dcterms:W3CDTF">2022-07-25T01:50:16Z</dcterms:modified>
</cp:coreProperties>
</file>